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174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34343"/>
    <a:srgbClr val="393939"/>
    <a:srgbClr val="4D4D4D"/>
    <a:srgbClr val="45454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622"/>
    <p:restoredTop sz="95510"/>
  </p:normalViewPr>
  <p:slideViewPr>
    <p:cSldViewPr snapToGrid="0">
      <p:cViewPr>
        <p:scale>
          <a:sx n="254" d="100"/>
          <a:sy n="254" d="100"/>
        </p:scale>
        <p:origin x="240" y="-10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0577C9-7F0F-2F44-91C9-3A995B29DEEE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A87E26-EF96-AB4C-8047-13E4C86D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770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A87E26-EF96-AB4C-8047-13E4C86D60F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725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10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00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954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818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965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774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5488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278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68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50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193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AD5C57-7226-E648-9E43-A49C4886F094}" type="datetimeFigureOut">
              <a:rPr kumimoji="1" lang="ja-JP" altLang="en-US" smtClean="0"/>
              <a:t>2024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794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B11485F-8EE9-2711-52D5-AAB75D3B7D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6866375"/>
              </p:ext>
            </p:extLst>
          </p:nvPr>
        </p:nvGraphicFramePr>
        <p:xfrm>
          <a:off x="941012" y="634281"/>
          <a:ext cx="4975971" cy="3195467"/>
        </p:xfrm>
        <a:graphic>
          <a:graphicData uri="http://schemas.openxmlformats.org/drawingml/2006/table">
            <a:tbl>
              <a:tblPr/>
              <a:tblGrid>
                <a:gridCol w="2711564">
                  <a:extLst>
                    <a:ext uri="{9D8B030D-6E8A-4147-A177-3AD203B41FA5}">
                      <a16:colId xmlns:a16="http://schemas.microsoft.com/office/drawing/2014/main" val="3318038385"/>
                    </a:ext>
                  </a:extLst>
                </a:gridCol>
                <a:gridCol w="2264407">
                  <a:extLst>
                    <a:ext uri="{9D8B030D-6E8A-4147-A177-3AD203B41FA5}">
                      <a16:colId xmlns:a16="http://schemas.microsoft.com/office/drawing/2014/main" val="1942220918"/>
                    </a:ext>
                  </a:extLst>
                </a:gridCol>
              </a:tblGrid>
              <a:tr h="26016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Primers</a:t>
                      </a:r>
                      <a:endParaRPr lang="ja-JP" altLang="en-US" sz="1100" b="1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equence 5’ → 3’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7460766"/>
                  </a:ext>
                </a:extLst>
              </a:tr>
              <a:tr h="223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dr_F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/</a:t>
                      </a:r>
                      <a:r>
                        <a:rPr kumimoji="1" lang="en-GB" altLang="ja-GB" sz="1100" i="1" kern="1200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taggctacagcagccatc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5817454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dr_R1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/</a:t>
                      </a:r>
                      <a:r>
                        <a:rPr kumimoji="1" lang="en-GB" altLang="ja-GB" sz="1100" i="1" kern="1200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taccaggaaatgtggcgct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2535090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dr_R2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/</a:t>
                      </a:r>
                      <a:r>
                        <a:rPr kumimoji="1" lang="en-GB" altLang="ja-GB" sz="1100" i="1" kern="1200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Δdr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agttgatcaccaacccgct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007521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+/-_F1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/-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gaacagtatctgccctttgt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9178087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+/-_F2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/-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tggaaggtgccactcccac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1321219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+/-_R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for </a:t>
                      </a:r>
                      <a:r>
                        <a:rPr kumimoji="1" lang="en-GB" altLang="ja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ox17</a:t>
                      </a:r>
                      <a:r>
                        <a:rPr kumimoji="1" lang="en-GB" altLang="ja-GB" sz="1100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/-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enotypin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aatctcgtgtagcccctca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4228410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1_exon2_F(target α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gagaatggtcagcagaagtta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9752072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1_exon2_R(target α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agtagcgggtccagaat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1648280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1_exon3_F(target β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aacactcctcccaaagta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0816268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SOX17exon1_exon3_R(target β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gggaaataggaaggctgaaa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6217591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SOX17exon4_exon5_F(target γ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tttatggtgtgggccaaa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6957031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SOX17exon4_exon5_R(target γ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cttccaagacttgcctagca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079456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K19_F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gacctggagatgcagattga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1127293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K19_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gctcctcagggcagtaatt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7960085"/>
                  </a:ext>
                </a:extLst>
              </a:tr>
            </a:tbl>
          </a:graphicData>
        </a:graphic>
      </p:graphicFrame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F72C46E-19AC-A691-B8BE-98F8B47DB3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6026859"/>
              </p:ext>
            </p:extLst>
          </p:nvPr>
        </p:nvGraphicFramePr>
        <p:xfrm>
          <a:off x="941011" y="5647596"/>
          <a:ext cx="4975972" cy="25119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49539">
                  <a:extLst>
                    <a:ext uri="{9D8B030D-6E8A-4147-A177-3AD203B41FA5}">
                      <a16:colId xmlns:a16="http://schemas.microsoft.com/office/drawing/2014/main" val="838360870"/>
                    </a:ext>
                  </a:extLst>
                </a:gridCol>
                <a:gridCol w="1257133">
                  <a:extLst>
                    <a:ext uri="{9D8B030D-6E8A-4147-A177-3AD203B41FA5}">
                      <a16:colId xmlns:a16="http://schemas.microsoft.com/office/drawing/2014/main" val="2743011520"/>
                    </a:ext>
                  </a:extLst>
                </a:gridCol>
                <a:gridCol w="884650">
                  <a:extLst>
                    <a:ext uri="{9D8B030D-6E8A-4147-A177-3AD203B41FA5}">
                      <a16:colId xmlns:a16="http://schemas.microsoft.com/office/drawing/2014/main" val="665620164"/>
                    </a:ext>
                  </a:extLst>
                </a:gridCol>
                <a:gridCol w="884650">
                  <a:extLst>
                    <a:ext uri="{9D8B030D-6E8A-4147-A177-3AD203B41FA5}">
                      <a16:colId xmlns:a16="http://schemas.microsoft.com/office/drawing/2014/main" val="1962277107"/>
                    </a:ext>
                  </a:extLst>
                </a:gridCol>
              </a:tblGrid>
              <a:tr h="30829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ompany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at No.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ilution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1339150"/>
                  </a:ext>
                </a:extLst>
              </a:tr>
              <a:tr h="403989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anti-SOX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-Aldrich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553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:400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4045422"/>
                  </a:ext>
                </a:extLst>
              </a:tr>
              <a:tr h="403989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SOX17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&amp;D Syste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19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:100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134384"/>
                  </a:ext>
                </a:extLst>
              </a:tr>
              <a:tr h="467492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488 conjugated Chicken anti-Rabbit Ig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144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:400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4220242"/>
                  </a:ext>
                </a:extLst>
              </a:tr>
              <a:tr h="403989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JINDO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0-0797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:5000</a:t>
                      </a: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4621325"/>
                  </a:ext>
                </a:extLst>
              </a:tr>
              <a:tr h="52417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A lectin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ctor Laboratorie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L-103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en-GB" altLang="ja-JP" sz="1100" u="none" strike="noStrike" dirty="0">
                          <a:effectLst/>
                          <a:latin typeface="Symbol" pitchFamily="2" charset="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m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072" marR="9072" marT="90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791994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63FF514-05B9-D5E6-2631-A2D120D25433}"/>
              </a:ext>
            </a:extLst>
          </p:cNvPr>
          <p:cNvSpPr txBox="1"/>
          <p:nvPr/>
        </p:nvSpPr>
        <p:spPr>
          <a:xfrm>
            <a:off x="0" y="3265"/>
            <a:ext cx="3955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172E5B4C-5618-F35F-5DBF-4DA2A7DF42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54653"/>
              </p:ext>
            </p:extLst>
          </p:nvPr>
        </p:nvGraphicFramePr>
        <p:xfrm>
          <a:off x="941011" y="3987081"/>
          <a:ext cx="4975972" cy="1503182"/>
        </p:xfrm>
        <a:graphic>
          <a:graphicData uri="http://schemas.openxmlformats.org/drawingml/2006/table">
            <a:tbl>
              <a:tblPr/>
              <a:tblGrid>
                <a:gridCol w="1454716">
                  <a:extLst>
                    <a:ext uri="{9D8B030D-6E8A-4147-A177-3AD203B41FA5}">
                      <a16:colId xmlns:a16="http://schemas.microsoft.com/office/drawing/2014/main" val="3318038385"/>
                    </a:ext>
                  </a:extLst>
                </a:gridCol>
                <a:gridCol w="2261901">
                  <a:extLst>
                    <a:ext uri="{9D8B030D-6E8A-4147-A177-3AD203B41FA5}">
                      <a16:colId xmlns:a16="http://schemas.microsoft.com/office/drawing/2014/main" val="1942220918"/>
                    </a:ext>
                  </a:extLst>
                </a:gridCol>
                <a:gridCol w="1259355">
                  <a:extLst>
                    <a:ext uri="{9D8B030D-6E8A-4147-A177-3AD203B41FA5}">
                      <a16:colId xmlns:a16="http://schemas.microsoft.com/office/drawing/2014/main" val="4279089052"/>
                    </a:ext>
                  </a:extLst>
                </a:gridCol>
              </a:tblGrid>
              <a:tr h="26016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Probes</a:t>
                      </a:r>
                      <a:endParaRPr lang="ja-JP" altLang="en-US" sz="1100" b="1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equence 5’ → 3’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Dye/Quench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7460766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1_exon2</a:t>
                      </a:r>
                    </a:p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target α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tcaaccaagacagggaagacagag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GB" altLang="ja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AM/ZEN/IBFQ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2717191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1_exon3</a:t>
                      </a:r>
                    </a:p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target β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tgagcagcacctccagacatct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AM/ZEN/IBFQ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ja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7100677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SOX17exon4_exon5</a:t>
                      </a:r>
                    </a:p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target γ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atctgcacaacgcagagctaagc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GB" altLang="ja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AM/ZEN/IBFQ</a:t>
                      </a:r>
                      <a:r>
                        <a:rPr lang="ja-GB" altLang="ja-GB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altLang="ja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3450834"/>
                  </a:ext>
                </a:extLst>
              </a:tr>
              <a:tr h="20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 CK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tggttcttcttcaggtaggccag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GB" altLang="ja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N-ZEN-IBFQ</a:t>
                      </a:r>
                      <a:r>
                        <a:rPr lang="ja-GB" altLang="ja-GB" sz="1100" dirty="0">
                          <a:effectLst/>
                        </a:rPr>
                        <a:t>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3970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4581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35</TotalTime>
  <Words>275</Words>
  <Application>Microsoft Macintosh PowerPoint</Application>
  <PresentationFormat>A4 210 x 297 mm</PresentationFormat>
  <Paragraphs>7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曽　詩涵</dc:creator>
  <cp:lastModifiedBy>Ayaka Yanagida</cp:lastModifiedBy>
  <cp:revision>290</cp:revision>
  <cp:lastPrinted>2024-10-30T10:16:23Z</cp:lastPrinted>
  <dcterms:created xsi:type="dcterms:W3CDTF">2024-05-27T07:05:45Z</dcterms:created>
  <dcterms:modified xsi:type="dcterms:W3CDTF">2024-10-30T10:19:51Z</dcterms:modified>
</cp:coreProperties>
</file>